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34" d="100"/>
          <a:sy n="34" d="100"/>
        </p:scale>
        <p:origin x="1794" y="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346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436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4463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6287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8121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854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1893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7449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6896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10480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02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027325-2EB6-4015-B2A2-BA757B84C812}" type="datetimeFigureOut">
              <a:rPr lang="en-US" smtClean="0"/>
              <a:t>9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169EDC-9B2B-402F-862F-27C666B50D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26039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226820" y="6619932"/>
            <a:ext cx="2426970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Cohort Enrollees 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1,374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3148965" y="5698008"/>
            <a:ext cx="2426970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Reached but Refused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5,564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3148965" y="3522554"/>
            <a:ext cx="2400300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Never Reached 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6,717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181100" y="4466691"/>
            <a:ext cx="2426970" cy="89297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Reached and Invited to Cohort 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6,938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565785" y="2629821"/>
            <a:ext cx="3657600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Attempted to Reach for Cohort 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13,655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1" name="Rectangle 10"/>
          <p:cNvSpPr/>
          <p:nvPr/>
        </p:nvSpPr>
        <p:spPr>
          <a:xfrm>
            <a:off x="605790" y="1589546"/>
            <a:ext cx="3657600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Potentially Eligible Pregnant Women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13,655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5" name="Down Arrow 14"/>
          <p:cNvSpPr/>
          <p:nvPr/>
        </p:nvSpPr>
        <p:spPr>
          <a:xfrm>
            <a:off x="2280285" y="3312718"/>
            <a:ext cx="297180" cy="1076865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6" name="Down Arrow 15"/>
          <p:cNvSpPr/>
          <p:nvPr/>
        </p:nvSpPr>
        <p:spPr>
          <a:xfrm>
            <a:off x="2291715" y="5427453"/>
            <a:ext cx="297180" cy="1076865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9" name="Right Arrow 18"/>
          <p:cNvSpPr/>
          <p:nvPr/>
        </p:nvSpPr>
        <p:spPr>
          <a:xfrm>
            <a:off x="2655473" y="3706466"/>
            <a:ext cx="415484" cy="289367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0" name="Right Arrow 19"/>
          <p:cNvSpPr/>
          <p:nvPr/>
        </p:nvSpPr>
        <p:spPr>
          <a:xfrm>
            <a:off x="2655473" y="5865502"/>
            <a:ext cx="415484" cy="289367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2" name="Down Arrow 21"/>
          <p:cNvSpPr/>
          <p:nvPr/>
        </p:nvSpPr>
        <p:spPr>
          <a:xfrm>
            <a:off x="2291715" y="2249120"/>
            <a:ext cx="297180" cy="326917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65785" y="609307"/>
            <a:ext cx="58778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A</a:t>
            </a:r>
            <a:r>
              <a:rPr lang="en-US" b="1" dirty="0"/>
              <a:t>:</a:t>
            </a:r>
            <a:r>
              <a:rPr lang="en-US" b="1" dirty="0" smtClean="0"/>
              <a:t> Recruitment in Year 1 as Cohort or Medical Enrollees</a:t>
            </a:r>
            <a:endParaRPr lang="en-US" b="1" dirty="0"/>
          </a:p>
        </p:txBody>
      </p:sp>
      <p:sp>
        <p:nvSpPr>
          <p:cNvPr id="24" name="Rectangle 23"/>
          <p:cNvSpPr/>
          <p:nvPr/>
        </p:nvSpPr>
        <p:spPr>
          <a:xfrm>
            <a:off x="4223385" y="7570567"/>
            <a:ext cx="2426970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Medical Enrollees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151</a:t>
            </a:r>
            <a:endParaRPr lang="en-US" dirty="0">
              <a:solidFill>
                <a:schemeClr val="tx1"/>
              </a:solidFill>
            </a:endParaRPr>
          </a:p>
        </p:txBody>
      </p:sp>
      <p:cxnSp>
        <p:nvCxnSpPr>
          <p:cNvPr id="26" name="Elbow Connector 25"/>
          <p:cNvCxnSpPr>
            <a:stCxn id="7" idx="3"/>
          </p:cNvCxnSpPr>
          <p:nvPr/>
        </p:nvCxnSpPr>
        <p:spPr>
          <a:xfrm>
            <a:off x="5549265" y="3825449"/>
            <a:ext cx="611505" cy="3716407"/>
          </a:xfrm>
          <a:prstGeom prst="bentConnector2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Elbow Connector 27"/>
          <p:cNvCxnSpPr>
            <a:stCxn id="6" idx="3"/>
          </p:cNvCxnSpPr>
          <p:nvPr/>
        </p:nvCxnSpPr>
        <p:spPr>
          <a:xfrm>
            <a:off x="5575935" y="6000903"/>
            <a:ext cx="367665" cy="1540953"/>
          </a:xfrm>
          <a:prstGeom prst="bentConnector2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2119742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58443" y="6830786"/>
            <a:ext cx="2426970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ARI-Negative Controls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103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847725" y="6802674"/>
            <a:ext cx="2426970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Medical Enrollees 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151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4155660" y="5486836"/>
            <a:ext cx="2344200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Reached but Refused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514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7" name="Rectangle 6"/>
          <p:cNvSpPr/>
          <p:nvPr/>
        </p:nvSpPr>
        <p:spPr>
          <a:xfrm>
            <a:off x="4143375" y="3563715"/>
            <a:ext cx="2356485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Never Reached </a:t>
            </a:r>
          </a:p>
          <a:p>
            <a:pPr algn="ctr"/>
            <a:r>
              <a:rPr lang="en-US" i="1" dirty="0" smtClean="0">
                <a:solidFill>
                  <a:schemeClr val="tx1"/>
                </a:solidFill>
              </a:rPr>
              <a:t>Unknown in Year 2</a:t>
            </a:r>
            <a:endParaRPr lang="en-US" i="1" dirty="0">
              <a:solidFill>
                <a:schemeClr val="tx1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1600200" y="1565729"/>
            <a:ext cx="3657600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Potentially Eligible Pregnant Women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19, 264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2232660" y="4542275"/>
            <a:ext cx="2426970" cy="61974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Reached and Invited </a:t>
            </a:r>
          </a:p>
          <a:p>
            <a:pPr algn="ctr"/>
            <a:r>
              <a:rPr lang="en-US" dirty="0" smtClean="0">
                <a:solidFill>
                  <a:schemeClr val="tx1"/>
                </a:solidFill>
              </a:rPr>
              <a:t>N = 768</a:t>
            </a:r>
            <a:endParaRPr lang="en-US" dirty="0">
              <a:solidFill>
                <a:schemeClr val="tx1"/>
              </a:solidFill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600200" y="2622944"/>
            <a:ext cx="3657600" cy="60579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Attempted to Reach </a:t>
            </a:r>
          </a:p>
          <a:p>
            <a:pPr algn="ctr"/>
            <a:r>
              <a:rPr lang="en-US" i="1" dirty="0" smtClean="0">
                <a:solidFill>
                  <a:schemeClr val="tx1"/>
                </a:solidFill>
              </a:rPr>
              <a:t>Unknown in Year 2</a:t>
            </a:r>
            <a:endParaRPr lang="en-US" i="1" dirty="0">
              <a:solidFill>
                <a:schemeClr val="tx1"/>
              </a:solidFill>
            </a:endParaRPr>
          </a:p>
        </p:txBody>
      </p:sp>
      <p:sp>
        <p:nvSpPr>
          <p:cNvPr id="11" name="Down Arrow 10"/>
          <p:cNvSpPr/>
          <p:nvPr/>
        </p:nvSpPr>
        <p:spPr>
          <a:xfrm>
            <a:off x="3286125" y="2249120"/>
            <a:ext cx="297180" cy="326917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80560" y="429418"/>
            <a:ext cx="5668328" cy="92333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Figure B:  </a:t>
            </a:r>
            <a:r>
              <a:rPr lang="en-US" b="1" dirty="0"/>
              <a:t>Recruitment in Year </a:t>
            </a:r>
            <a:r>
              <a:rPr lang="en-US" b="1" dirty="0" smtClean="0"/>
              <a:t>2 </a:t>
            </a:r>
            <a:r>
              <a:rPr lang="en-US" b="1" dirty="0"/>
              <a:t>as </a:t>
            </a:r>
            <a:r>
              <a:rPr lang="en-US" b="1" dirty="0" smtClean="0"/>
              <a:t>Medical Enrollees or Acute Respiratory Illness (ARI) Negative Controls </a:t>
            </a:r>
            <a:endParaRPr lang="en-US" b="1" dirty="0"/>
          </a:p>
        </p:txBody>
      </p:sp>
      <p:sp>
        <p:nvSpPr>
          <p:cNvPr id="13" name="Down Arrow 12"/>
          <p:cNvSpPr/>
          <p:nvPr/>
        </p:nvSpPr>
        <p:spPr>
          <a:xfrm>
            <a:off x="3274695" y="3312718"/>
            <a:ext cx="297180" cy="1076865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4" name="Down Arrow 13"/>
          <p:cNvSpPr/>
          <p:nvPr/>
        </p:nvSpPr>
        <p:spPr>
          <a:xfrm>
            <a:off x="3274695" y="5284598"/>
            <a:ext cx="297180" cy="1076865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5" name="Right Arrow 14"/>
          <p:cNvSpPr/>
          <p:nvPr/>
        </p:nvSpPr>
        <p:spPr>
          <a:xfrm>
            <a:off x="3649883" y="3706466"/>
            <a:ext cx="415484" cy="289367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6" name="Right Arrow 15"/>
          <p:cNvSpPr/>
          <p:nvPr/>
        </p:nvSpPr>
        <p:spPr>
          <a:xfrm>
            <a:off x="3667028" y="5645047"/>
            <a:ext cx="415484" cy="289367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7" name="Down Arrow 16"/>
          <p:cNvSpPr/>
          <p:nvPr/>
        </p:nvSpPr>
        <p:spPr>
          <a:xfrm rot="2909497">
            <a:off x="2979243" y="6382140"/>
            <a:ext cx="297180" cy="326917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sp>
        <p:nvSpPr>
          <p:cNvPr id="18" name="Down Arrow 17"/>
          <p:cNvSpPr/>
          <p:nvPr/>
        </p:nvSpPr>
        <p:spPr>
          <a:xfrm rot="18913305">
            <a:off x="3586744" y="6418524"/>
            <a:ext cx="297180" cy="326917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823810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8</TotalTime>
  <Words>121</Words>
  <Application>Microsoft Office PowerPoint</Application>
  <PresentationFormat>Letter Paper (8.5x11 in)</PresentationFormat>
  <Paragraphs>3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>Centers for Disease Control and Preven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hompson, Mark (CDC/OID/NCIRD)</dc:creator>
  <cp:lastModifiedBy>Thompson, Mark (CDC/OID/NCIRD)</cp:lastModifiedBy>
  <cp:revision>8</cp:revision>
  <dcterms:created xsi:type="dcterms:W3CDTF">2018-09-22T19:51:54Z</dcterms:created>
  <dcterms:modified xsi:type="dcterms:W3CDTF">2018-09-22T21:52:16Z</dcterms:modified>
</cp:coreProperties>
</file>